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1092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AD98D-EFDC-43F8-9777-58884CDF0F55}" type="datetimeFigureOut">
              <a:rPr lang="en-US" smtClean="0"/>
              <a:t>3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F1B6B-2B68-4D2A-810D-4268F10DAC3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AD98D-EFDC-43F8-9777-58884CDF0F55}" type="datetimeFigureOut">
              <a:rPr lang="en-US" smtClean="0"/>
              <a:t>3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F1B6B-2B68-4D2A-810D-4268F10DAC3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AD98D-EFDC-43F8-9777-58884CDF0F55}" type="datetimeFigureOut">
              <a:rPr lang="en-US" smtClean="0"/>
              <a:t>3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F1B6B-2B68-4D2A-810D-4268F10DAC3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AD98D-EFDC-43F8-9777-58884CDF0F55}" type="datetimeFigureOut">
              <a:rPr lang="en-US" smtClean="0"/>
              <a:t>3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F1B6B-2B68-4D2A-810D-4268F10DAC3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AD98D-EFDC-43F8-9777-58884CDF0F55}" type="datetimeFigureOut">
              <a:rPr lang="en-US" smtClean="0"/>
              <a:t>3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F1B6B-2B68-4D2A-810D-4268F10DAC3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AD98D-EFDC-43F8-9777-58884CDF0F55}" type="datetimeFigureOut">
              <a:rPr lang="en-US" smtClean="0"/>
              <a:t>3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F1B6B-2B68-4D2A-810D-4268F10DAC3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AD98D-EFDC-43F8-9777-58884CDF0F55}" type="datetimeFigureOut">
              <a:rPr lang="en-US" smtClean="0"/>
              <a:t>3/2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F1B6B-2B68-4D2A-810D-4268F10DAC3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AD98D-EFDC-43F8-9777-58884CDF0F55}" type="datetimeFigureOut">
              <a:rPr lang="en-US" smtClean="0"/>
              <a:t>3/2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F1B6B-2B68-4D2A-810D-4268F10DAC3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AD98D-EFDC-43F8-9777-58884CDF0F55}" type="datetimeFigureOut">
              <a:rPr lang="en-US" smtClean="0"/>
              <a:t>3/2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F1B6B-2B68-4D2A-810D-4268F10DAC3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AD98D-EFDC-43F8-9777-58884CDF0F55}" type="datetimeFigureOut">
              <a:rPr lang="en-US" smtClean="0"/>
              <a:t>3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F1B6B-2B68-4D2A-810D-4268F10DAC3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AD98D-EFDC-43F8-9777-58884CDF0F55}" type="datetimeFigureOut">
              <a:rPr lang="en-US" smtClean="0"/>
              <a:t>3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F1B6B-2B68-4D2A-810D-4268F10DAC3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AD98D-EFDC-43F8-9777-58884CDF0F55}" type="datetimeFigureOut">
              <a:rPr lang="en-US" smtClean="0"/>
              <a:t>3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4F1B6B-2B68-4D2A-810D-4268F10DAC33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429000" y="2895600"/>
            <a:ext cx="5715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/>
              <a:t>	Number	% of </a:t>
            </a:r>
            <a:r>
              <a:rPr lang="en-US" sz="1200" dirty="0" err="1" smtClean="0"/>
              <a:t>vis</a:t>
            </a:r>
            <a:r>
              <a:rPr lang="en-US" sz="1200" dirty="0" smtClean="0"/>
              <a:t>	X mean	X </a:t>
            </a:r>
            <a:r>
              <a:rPr lang="en-US" sz="1200" dirty="0" err="1" smtClean="0"/>
              <a:t>geomean</a:t>
            </a:r>
            <a:r>
              <a:rPr lang="en-US" sz="1200" dirty="0" smtClean="0"/>
              <a:t>	CV</a:t>
            </a:r>
          </a:p>
          <a:p>
            <a:r>
              <a:rPr lang="en-US" sz="1200" dirty="0" smtClean="0"/>
              <a:t>Visible	9664	100	2.95	1.74	672.04</a:t>
            </a:r>
          </a:p>
          <a:p>
            <a:r>
              <a:rPr lang="en-US" sz="1200" dirty="0" smtClean="0"/>
              <a:t>Histo-6	119	1.23	68.22	18.14	242.78</a:t>
            </a:r>
            <a:endParaRPr lang="en-US" sz="1200" dirty="0"/>
          </a:p>
        </p:txBody>
      </p:sp>
      <p:pic>
        <p:nvPicPr>
          <p:cNvPr id="5" name="Picture 7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1981200"/>
            <a:ext cx="2400300" cy="2990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TextBox 5"/>
          <p:cNvSpPr txBox="1"/>
          <p:nvPr/>
        </p:nvSpPr>
        <p:spPr>
          <a:xfrm>
            <a:off x="1219200" y="1143000"/>
            <a:ext cx="58409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TLA-4 expression when stimulated with anti-CD3 anti-CD28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34636" y="76200"/>
            <a:ext cx="20094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ata not shown #1.</a:t>
            </a:r>
            <a:endParaRPr 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90725" y="2033588"/>
            <a:ext cx="5162550" cy="2790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extBox 2"/>
          <p:cNvSpPr txBox="1"/>
          <p:nvPr/>
        </p:nvSpPr>
        <p:spPr>
          <a:xfrm>
            <a:off x="34636" y="76200"/>
            <a:ext cx="20094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ata not shown #2.</a:t>
            </a:r>
            <a:endParaRPr 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971800" y="2819400"/>
            <a:ext cx="58674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/>
              <a:t>	Number	% of </a:t>
            </a:r>
            <a:r>
              <a:rPr lang="en-US" sz="1200" dirty="0" err="1" smtClean="0"/>
              <a:t>vis</a:t>
            </a:r>
            <a:r>
              <a:rPr lang="en-US" sz="1200" dirty="0" smtClean="0"/>
              <a:t>	X mean	X </a:t>
            </a:r>
            <a:r>
              <a:rPr lang="en-US" sz="1200" dirty="0" err="1" smtClean="0"/>
              <a:t>geomean</a:t>
            </a:r>
            <a:r>
              <a:rPr lang="en-US" sz="1200" dirty="0" smtClean="0"/>
              <a:t>	CV</a:t>
            </a:r>
          </a:p>
          <a:p>
            <a:r>
              <a:rPr lang="en-US" sz="1200" dirty="0" smtClean="0"/>
              <a:t>Visible	9671	100	2.82	1.71	702.32</a:t>
            </a:r>
          </a:p>
          <a:p>
            <a:r>
              <a:rPr lang="en-US" sz="1200" dirty="0" smtClean="0"/>
              <a:t>Histo-6	92	0.95	76.93	19.47	245.27</a:t>
            </a:r>
            <a:endParaRPr lang="en-US" sz="1200" dirty="0"/>
          </a:p>
        </p:txBody>
      </p:sp>
      <p:pic>
        <p:nvPicPr>
          <p:cNvPr id="3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04800" y="1905000"/>
            <a:ext cx="2400300" cy="2990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TextBox 3"/>
          <p:cNvSpPr txBox="1"/>
          <p:nvPr/>
        </p:nvSpPr>
        <p:spPr>
          <a:xfrm>
            <a:off x="2514600" y="1676400"/>
            <a:ext cx="36953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D80 expression with LPS stimulation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34636" y="76200"/>
            <a:ext cx="20094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ata not shown #3.</a:t>
            </a:r>
            <a:endParaRPr lang="en-US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1219200" y="1966913"/>
          <a:ext cx="6705600" cy="29260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57412"/>
                <a:gridCol w="525929"/>
                <a:gridCol w="525929"/>
                <a:gridCol w="657412"/>
                <a:gridCol w="657412"/>
                <a:gridCol w="657412"/>
                <a:gridCol w="657412"/>
                <a:gridCol w="525929"/>
                <a:gridCol w="525929"/>
                <a:gridCol w="657412"/>
                <a:gridCol w="657412"/>
              </a:tblGrid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NF-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round Contro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STS mic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round Contro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STS mic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lagelli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6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IL-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round Contro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STS mic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round Contro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STS mic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lagelli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34636" y="76200"/>
            <a:ext cx="20094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ata not shown #4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959664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145</Words>
  <Application>Microsoft Office PowerPoint</Application>
  <PresentationFormat>On-screen Show (4:3)</PresentationFormat>
  <Paragraphs>11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hwang</dc:creator>
  <cp:lastModifiedBy>Douglas Surwilo</cp:lastModifiedBy>
  <cp:revision>5</cp:revision>
  <dcterms:created xsi:type="dcterms:W3CDTF">2015-03-06T20:35:46Z</dcterms:created>
  <dcterms:modified xsi:type="dcterms:W3CDTF">2015-03-23T21:18:19Z</dcterms:modified>
</cp:coreProperties>
</file>